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0" autoAdjust="0"/>
    <p:restoredTop sz="94660"/>
  </p:normalViewPr>
  <p:slideViewPr>
    <p:cSldViewPr snapToGrid="0">
      <p:cViewPr>
        <p:scale>
          <a:sx n="100" d="100"/>
          <a:sy n="100" d="100"/>
        </p:scale>
        <p:origin x="-72" y="1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0BA59-B20B-4125-9675-48423BB5A5F5}" type="datetimeFigureOut">
              <a:rPr lang="pt-BR" smtClean="0"/>
              <a:t>21/12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39A8B-7921-4490-8112-C8125F8596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39235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0BA59-B20B-4125-9675-48423BB5A5F5}" type="datetimeFigureOut">
              <a:rPr lang="pt-BR" smtClean="0"/>
              <a:t>21/12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39A8B-7921-4490-8112-C8125F8596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17708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0BA59-B20B-4125-9675-48423BB5A5F5}" type="datetimeFigureOut">
              <a:rPr lang="pt-BR" smtClean="0"/>
              <a:t>21/12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39A8B-7921-4490-8112-C8125F8596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73286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0BA59-B20B-4125-9675-48423BB5A5F5}" type="datetimeFigureOut">
              <a:rPr lang="pt-BR" smtClean="0"/>
              <a:t>21/12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39A8B-7921-4490-8112-C8125F8596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33987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0BA59-B20B-4125-9675-48423BB5A5F5}" type="datetimeFigureOut">
              <a:rPr lang="pt-BR" smtClean="0"/>
              <a:t>21/12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39A8B-7921-4490-8112-C8125F8596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5527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0BA59-B20B-4125-9675-48423BB5A5F5}" type="datetimeFigureOut">
              <a:rPr lang="pt-BR" smtClean="0"/>
              <a:t>21/12/2017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39A8B-7921-4490-8112-C8125F8596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8633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0BA59-B20B-4125-9675-48423BB5A5F5}" type="datetimeFigureOut">
              <a:rPr lang="pt-BR" smtClean="0"/>
              <a:t>21/12/2017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39A8B-7921-4490-8112-C8125F8596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52925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0BA59-B20B-4125-9675-48423BB5A5F5}" type="datetimeFigureOut">
              <a:rPr lang="pt-BR" smtClean="0"/>
              <a:t>21/12/2017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39A8B-7921-4490-8112-C8125F8596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37527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0BA59-B20B-4125-9675-48423BB5A5F5}" type="datetimeFigureOut">
              <a:rPr lang="pt-BR" smtClean="0"/>
              <a:t>21/12/2017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39A8B-7921-4490-8112-C8125F8596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69072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0BA59-B20B-4125-9675-48423BB5A5F5}" type="datetimeFigureOut">
              <a:rPr lang="pt-BR" smtClean="0"/>
              <a:t>21/12/2017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39A8B-7921-4490-8112-C8125F8596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0532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0BA59-B20B-4125-9675-48423BB5A5F5}" type="datetimeFigureOut">
              <a:rPr lang="pt-BR" smtClean="0"/>
              <a:t>21/12/2017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39A8B-7921-4490-8112-C8125F8596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79152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20BA59-B20B-4125-9675-48423BB5A5F5}" type="datetimeFigureOut">
              <a:rPr lang="pt-BR" smtClean="0"/>
              <a:t>21/12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39A8B-7921-4490-8112-C8125F8596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02163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Imagem 26"/>
          <p:cNvPicPr>
            <a:picLocks noChangeAspect="1"/>
          </p:cNvPicPr>
          <p:nvPr/>
        </p:nvPicPr>
        <p:blipFill rotWithShape="1">
          <a:blip r:embed="rId2"/>
          <a:srcRect l="1847" t="2600"/>
          <a:stretch/>
        </p:blipFill>
        <p:spPr>
          <a:xfrm>
            <a:off x="2465848" y="240030"/>
            <a:ext cx="7260304" cy="4638742"/>
          </a:xfrm>
          <a:prstGeom prst="rect">
            <a:avLst/>
          </a:prstGeom>
        </p:spPr>
      </p:pic>
      <p:sp>
        <p:nvSpPr>
          <p:cNvPr id="2" name="Retângulo 1"/>
          <p:cNvSpPr/>
          <p:nvPr/>
        </p:nvSpPr>
        <p:spPr>
          <a:xfrm>
            <a:off x="582930" y="5095369"/>
            <a:ext cx="10984230" cy="11661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dditional file 8:  Figure S2. Proteins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from </a:t>
            </a:r>
            <a:r>
              <a:rPr lang="en-US" sz="1200" b="1" i="1" dirty="0" err="1">
                <a:latin typeface="Arial" pitchFamily="34" charset="0"/>
                <a:cs typeface="Arial" pitchFamily="34" charset="0"/>
              </a:rPr>
              <a:t>Aspergillus</a:t>
            </a:r>
            <a:r>
              <a:rPr lang="en-US" sz="1200" b="1" i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i="1" dirty="0" err="1">
                <a:latin typeface="Arial" pitchFamily="34" charset="0"/>
                <a:cs typeface="Arial" pitchFamily="34" charset="0"/>
              </a:rPr>
              <a:t>fumigatus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secretome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separated by SDS-PAGE.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liquots of 15 µL were loaded on top of a 10% separating gel. The gel was stained with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0.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%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Coomassie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Brilliant Blue R250 (w/v) and the lane indicated by L corresponds to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Spectra</a:t>
            </a:r>
            <a:r>
              <a:rPr lang="en-US" sz="1200" baseline="30000" dirty="0" err="1">
                <a:latin typeface="Arial" pitchFamily="34" charset="0"/>
                <a:cs typeface="Arial" pitchFamily="34" charset="0"/>
              </a:rPr>
              <a:t>TM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Multicolor Broad Range Protein Ladder (Thermo Scientific). The lanes indicated by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arabic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numerals 1, 2, 3 and 4 correspond to SEB samples and those indicated by 5, 6, 7, 8 and 9 correspond to fructose samples. Th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bands were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excised and identified by coupled system typ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LC/MS-MS.</a:t>
            </a:r>
            <a:endParaRPr lang="pt-BR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38767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Escritório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110</Words>
  <Application>Microsoft Office PowerPoint</Application>
  <PresentationFormat>Personalizar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Apresentação do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Aline Bernardi</dc:creator>
  <cp:lastModifiedBy>Taisa</cp:lastModifiedBy>
  <cp:revision>18</cp:revision>
  <dcterms:created xsi:type="dcterms:W3CDTF">2017-01-24T17:39:49Z</dcterms:created>
  <dcterms:modified xsi:type="dcterms:W3CDTF">2017-12-21T18:16:25Z</dcterms:modified>
</cp:coreProperties>
</file>